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drawings/drawing1.xml" ContentType="application/vnd.openxmlformats-officedocument.drawingml.chartshapes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61" r:id="rId3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9796" autoAdjust="0"/>
    <p:restoredTop sz="94660"/>
  </p:normalViewPr>
  <p:slideViewPr>
    <p:cSldViewPr>
      <p:cViewPr>
        <p:scale>
          <a:sx n="50" d="100"/>
          <a:sy n="50" d="100"/>
        </p:scale>
        <p:origin x="-1236" y="-9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&#35838;&#39064;2012.12.19\&#22269;&#33258;&#28982;&#37325;&#28857;-&#23454;&#39564;&#35745;&#21010;&#21450;&#32467;&#26524;2014\&#25991;&#31456;&#25237;&#31295;\figures%20and%20tables\Tables%20--PLAN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E:\&#35838;&#39064;2012.12.19\&#22269;&#33258;&#28982;&#37325;&#28857;-&#23454;&#39564;&#35745;&#21010;&#21450;&#32467;&#26524;2014\&#25991;&#31456;&#25237;&#31295;\figures%20and%20tables\Tables%20--PLAN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480324146981629"/>
          <c:y val="0.11759810193409"/>
          <c:w val="0.420347948510801"/>
          <c:h val="0.737988188737"/>
        </c:manualLayout>
      </c:layout>
      <c:barChart>
        <c:barDir val="bar"/>
        <c:grouping val="clustered"/>
        <c:varyColors val="0"/>
        <c:ser>
          <c:idx val="0"/>
          <c:order val="0"/>
          <c:tx>
            <c:strRef>
              <c:f>'GO&amp;Pathway'!$H$12</c:f>
              <c:strCache>
                <c:ptCount val="1"/>
                <c:pt idx="0">
                  <c:v>4709</c:v>
                </c:pt>
              </c:strCache>
            </c:strRef>
          </c:tx>
          <c:spPr>
            <a:solidFill>
              <a:schemeClr val="tx2">
                <a:lumMod val="60000"/>
                <a:lumOff val="40000"/>
              </a:schemeClr>
            </a:solidFill>
          </c:spPr>
          <c:invertIfNegative val="0"/>
          <c:dLbls>
            <c:delete val="1"/>
          </c:dLbls>
          <c:cat>
            <c:strRef>
              <c:f>'GO&amp;Pathway'!$G$1:$G$10</c:f>
              <c:strCache>
                <c:ptCount val="10"/>
                <c:pt idx="0">
                  <c:v>neuron development</c:v>
                </c:pt>
                <c:pt idx="1">
                  <c:v>regulation of establishment of protein localization in plasma membrane</c:v>
                </c:pt>
                <c:pt idx="2">
                  <c:v>cell development</c:v>
                </c:pt>
                <c:pt idx="3">
                  <c:v>neuron projection development</c:v>
                </c:pt>
                <c:pt idx="4">
                  <c:v>positive regulation of establishment of protein localization in plasma membrane</c:v>
                </c:pt>
                <c:pt idx="5">
                  <c:v>neurogenesis</c:v>
                </c:pt>
                <c:pt idx="6">
                  <c:v>nervous system development</c:v>
                </c:pt>
                <c:pt idx="7">
                  <c:v>neuron differentiation</c:v>
                </c:pt>
                <c:pt idx="8">
                  <c:v>generation of neurons</c:v>
                </c:pt>
                <c:pt idx="9">
                  <c:v>protein autophosphorylation</c:v>
                </c:pt>
              </c:strCache>
            </c:strRef>
          </c:cat>
          <c:val>
            <c:numRef>
              <c:f>'GO&amp;Pathway'!$J$1:$J$10</c:f>
              <c:numCache>
                <c:formatCode>General</c:formatCode>
                <c:ptCount val="10"/>
                <c:pt idx="0">
                  <c:v>3.57043321956628</c:v>
                </c:pt>
                <c:pt idx="1">
                  <c:v>3.57841924052566</c:v>
                </c:pt>
                <c:pt idx="2">
                  <c:v>3.78519766119593</c:v>
                </c:pt>
                <c:pt idx="3">
                  <c:v>4.0690486931197</c:v>
                </c:pt>
                <c:pt idx="4">
                  <c:v>4.43123319178067</c:v>
                </c:pt>
                <c:pt idx="5">
                  <c:v>4.57556612827205</c:v>
                </c:pt>
                <c:pt idx="6">
                  <c:v>4.85389096498147</c:v>
                </c:pt>
                <c:pt idx="7">
                  <c:v>5.05827527902817</c:v>
                </c:pt>
                <c:pt idx="8">
                  <c:v>5.11620967765179</c:v>
                </c:pt>
                <c:pt idx="9">
                  <c:v>5.1714077662194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8"/>
        <c:axId val="54519680"/>
        <c:axId val="54521216"/>
      </c:barChart>
      <c:catAx>
        <c:axId val="54519680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</c:spPr>
        <c:txPr>
          <a:bodyPr rot="-60000000" spcFirstLastPara="0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</a:p>
        </c:txPr>
        <c:crossAx val="54521216"/>
        <c:crosses val="autoZero"/>
        <c:auto val="1"/>
        <c:lblAlgn val="r"/>
        <c:lblOffset val="100"/>
        <c:noMultiLvlLbl val="0"/>
      </c:catAx>
      <c:valAx>
        <c:axId val="54521216"/>
        <c:scaling>
          <c:orientation val="minMax"/>
          <c:max val="6"/>
          <c:min val="0"/>
        </c:scaling>
        <c:delete val="0"/>
        <c:axPos val="b"/>
        <c:majorGridlines/>
        <c:numFmt formatCode="General" sourceLinked="1"/>
        <c:majorTickMark val="out"/>
        <c:minorTickMark val="none"/>
        <c:tickLblPos val="nextTo"/>
        <c:spPr>
          <a:ln w="25400" cap="flat" cmpd="sng" algn="ctr">
            <a:solidFill>
              <a:schemeClr val="tx1"/>
            </a:solidFill>
            <a:prstDash val="solid"/>
            <a:round/>
          </a:ln>
        </c:spPr>
        <c:txPr>
          <a:bodyPr rot="-60000000" spcFirstLastPara="0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</a:p>
        </c:txPr>
        <c:crossAx val="54519680"/>
        <c:crosses val="autoZero"/>
        <c:crossBetween val="between"/>
        <c:majorUnit val="1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lang="zh-CN"/>
      </a:pPr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5711565840183"/>
          <c:y val="0.0879783868529354"/>
          <c:w val="0.489011073410153"/>
          <c:h val="0.767607545369229"/>
        </c:manualLayout>
      </c:layout>
      <c:barChart>
        <c:barDir val="bar"/>
        <c:grouping val="clustered"/>
        <c:varyColors val="0"/>
        <c:ser>
          <c:idx val="0"/>
          <c:order val="0"/>
          <c:tx>
            <c:strRef>
              <c:f>4709</c:f>
              <c:strCache>
                <c:ptCount val="1"/>
                <c:pt idx="0">
                  <c:v>4709</c:v>
                </c:pt>
              </c:strCache>
            </c:strRef>
          </c:tx>
          <c:spPr>
            <a:solidFill>
              <a:schemeClr val="accent6">
                <a:lumMod val="75000"/>
              </a:schemeClr>
            </a:solidFill>
          </c:spPr>
          <c:invertIfNegative val="0"/>
          <c:dLbls>
            <c:delete val="1"/>
          </c:dLbls>
          <c:cat>
            <c:strRef>
              <c:f>'GO&amp;Pathway'!$G$18:$G$27</c:f>
              <c:strCache>
                <c:ptCount val="10"/>
                <c:pt idx="0">
                  <c:v>HIF-1 signaling pathway</c:v>
                </c:pt>
                <c:pt idx="1">
                  <c:v>Melanoma</c:v>
                </c:pt>
                <c:pt idx="2">
                  <c:v>Neurotrophin signaling pathway</c:v>
                </c:pt>
                <c:pt idx="3">
                  <c:v>Prostate cancer</c:v>
                </c:pt>
                <c:pt idx="4">
                  <c:v>Adrenergic signaling in cardiomyocytes</c:v>
                </c:pt>
                <c:pt idx="5">
                  <c:v>Inositol phosphate metabolism</c:v>
                </c:pt>
                <c:pt idx="6">
                  <c:v>Endometrial cancer</c:v>
                </c:pt>
                <c:pt idx="7">
                  <c:v>Glioma</c:v>
                </c:pt>
                <c:pt idx="8">
                  <c:v>Phosphatidylinositol signaling system</c:v>
                </c:pt>
                <c:pt idx="9">
                  <c:v>mTOR signaling pathway</c:v>
                </c:pt>
              </c:strCache>
            </c:strRef>
          </c:cat>
          <c:val>
            <c:numRef>
              <c:f>'GO&amp;Pathway'!$I$18:$I$27</c:f>
              <c:numCache>
                <c:formatCode>General</c:formatCode>
                <c:ptCount val="10"/>
                <c:pt idx="0">
                  <c:v>2.020386</c:v>
                </c:pt>
                <c:pt idx="1">
                  <c:v>2.14041</c:v>
                </c:pt>
                <c:pt idx="2">
                  <c:v>2.35456299999999</c:v>
                </c:pt>
                <c:pt idx="3">
                  <c:v>2.38625299999999</c:v>
                </c:pt>
                <c:pt idx="4">
                  <c:v>2.40312</c:v>
                </c:pt>
                <c:pt idx="5">
                  <c:v>2.421786</c:v>
                </c:pt>
                <c:pt idx="6">
                  <c:v>2.72836100000001</c:v>
                </c:pt>
                <c:pt idx="7">
                  <c:v>3.089014</c:v>
                </c:pt>
                <c:pt idx="8">
                  <c:v>3.34966599999999</c:v>
                </c:pt>
                <c:pt idx="9">
                  <c:v>4.17525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8"/>
        <c:axId val="55515392"/>
        <c:axId val="55525376"/>
      </c:barChart>
      <c:catAx>
        <c:axId val="5551539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</c:spPr>
        <c:txPr>
          <a:bodyPr rot="-60000000" spcFirstLastPara="0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</a:p>
        </c:txPr>
        <c:crossAx val="55525376"/>
        <c:crosses val="autoZero"/>
        <c:auto val="1"/>
        <c:lblAlgn val="r"/>
        <c:lblOffset val="100"/>
        <c:noMultiLvlLbl val="0"/>
      </c:catAx>
      <c:valAx>
        <c:axId val="55525376"/>
        <c:scaling>
          <c:orientation val="minMax"/>
          <c:max val="5"/>
          <c:min val="0"/>
        </c:scaling>
        <c:delete val="0"/>
        <c:axPos val="b"/>
        <c:majorGridlines/>
        <c:numFmt formatCode="General" sourceLinked="1"/>
        <c:majorTickMark val="out"/>
        <c:minorTickMark val="none"/>
        <c:tickLblPos val="nextTo"/>
        <c:spPr>
          <a:ln w="25400" cap="flat" cmpd="sng" algn="ctr">
            <a:solidFill>
              <a:schemeClr val="tx1"/>
            </a:solidFill>
            <a:prstDash val="solid"/>
            <a:round/>
          </a:ln>
        </c:spPr>
        <c:txPr>
          <a:bodyPr rot="-60000000" spcFirstLastPara="0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</a:p>
        </c:txPr>
        <c:crossAx val="55515392"/>
        <c:crosses val="autoZero"/>
        <c:crossBetween val="between"/>
        <c:majorUnit val="1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lang="zh-CN"/>
      </a:pPr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34892</cdr:x>
      <cdr:y>0.91383</cdr:y>
    </cdr:from>
    <cdr:to>
      <cdr:x>0.92028</cdr:x>
      <cdr:y>1</cdr:y>
    </cdr:to>
    <cdr:sp>
      <cdr:nvSpPr>
        <cdr:cNvPr id="2" name="矩形 1"/>
        <cdr:cNvSpPr/>
      </cdr:nvSpPr>
      <cdr:spPr xmlns:a="http://schemas.openxmlformats.org/drawingml/2006/main">
        <a:xfrm xmlns:a="http://schemas.openxmlformats.org/drawingml/2006/main">
          <a:off x="1875898" y="3429024"/>
          <a:ext cx="3071834" cy="276999"/>
        </a:xfrm>
        <a:prstGeom xmlns:a="http://schemas.openxmlformats.org/drawingml/2006/main" prst="rect">
          <a:avLst/>
        </a:prstGeom>
        <a:noFill/>
      </cdr:spPr>
      <cdr:txBody xmlns:a="http://schemas.openxmlformats.org/drawingml/2006/main">
        <a:bodyPr vert="horz" wrap="square" lIns="45720" tIns="45720" rIns="45720" bIns="45720" rtlCol="0" anchor="t" anchorCtr="0">
          <a:spAutoFit/>
        </a:bodyPr>
        <a:lstStyle>
          <a:defPPr>
            <a:defRPr lang="zh-CN"/>
          </a:defPPr>
          <a:lvl1pPr marL="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 panose="020F0502020204030204"/>
            </a:defRPr>
          </a:lvl1pPr>
          <a:lvl2pPr marL="4572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 panose="020F0502020204030204"/>
            </a:defRPr>
          </a:lvl2pPr>
          <a:lvl3pPr marL="9144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 panose="020F0502020204030204"/>
            </a:defRPr>
          </a:lvl3pPr>
          <a:lvl4pPr marL="13716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 panose="020F0502020204030204"/>
            </a:defRPr>
          </a:lvl4pPr>
          <a:lvl5pPr marL="18288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 panose="020F0502020204030204"/>
            </a:defRPr>
          </a:lvl5pPr>
          <a:lvl6pPr marL="22860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 panose="020F0502020204030204"/>
            </a:defRPr>
          </a:lvl6pPr>
          <a:lvl7pPr marL="27432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 panose="020F0502020204030204"/>
            </a:defRPr>
          </a:lvl7pPr>
          <a:lvl8pPr marL="32004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 panose="020F0502020204030204"/>
            </a:defRPr>
          </a:lvl8pPr>
          <a:lvl9pPr marL="36576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 panose="020F0502020204030204"/>
            </a:defRPr>
          </a:lvl9pPr>
        </a:lstStyle>
        <a:p>
          <a:r>
            <a:rPr lang="en-US" altLang="zh-CN" sz="1200" dirty="0" err="1" smtClean="0">
              <a:latin typeface="Arial" panose="020B0604020202020204" pitchFamily="34" charset="0"/>
              <a:cs typeface="Arial" panose="020B0604020202020204" pitchFamily="34" charset="0"/>
            </a:rPr>
            <a:t>Enrichment.Score</a:t>
          </a:r>
          <a:r>
            <a:rPr lang="en-US" altLang="zh-CN" sz="1200" dirty="0" smtClean="0">
              <a:latin typeface="Arial" panose="020B0604020202020204" pitchFamily="34" charset="0"/>
              <a:cs typeface="Arial" panose="020B0604020202020204" pitchFamily="34" charset="0"/>
            </a:rPr>
            <a:t>(-log10(P-value))</a:t>
          </a:r>
          <a:endParaRPr lang="zh-CN" altLang="en-US" sz="12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14953A2-41DF-456C-8E35-D349608663F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6408A91-25A6-4FB1-9D72-7CBD78955200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5D439-7D67-479D-BA16-E4467A70B23F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CEAE9-45EE-4036-8DC3-68BC050ACCA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5D439-7D67-479D-BA16-E4467A70B23F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CEAE9-45EE-4036-8DC3-68BC050ACCA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5D439-7D67-479D-BA16-E4467A70B23F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CEAE9-45EE-4036-8DC3-68BC050ACCA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5D439-7D67-479D-BA16-E4467A70B23F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CEAE9-45EE-4036-8DC3-68BC050ACCA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5D439-7D67-479D-BA16-E4467A70B23F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CEAE9-45EE-4036-8DC3-68BC050ACCA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5D439-7D67-479D-BA16-E4467A70B23F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CEAE9-45EE-4036-8DC3-68BC050ACCA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5D439-7D67-479D-BA16-E4467A70B23F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CEAE9-45EE-4036-8DC3-68BC050ACCA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5D439-7D67-479D-BA16-E4467A70B23F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CEAE9-45EE-4036-8DC3-68BC050ACCA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5D439-7D67-479D-BA16-E4467A70B23F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CEAE9-45EE-4036-8DC3-68BC050ACCA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5D439-7D67-479D-BA16-E4467A70B23F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CEAE9-45EE-4036-8DC3-68BC050ACCA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5D439-7D67-479D-BA16-E4467A70B23F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CEAE9-45EE-4036-8DC3-68BC050ACCA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25D439-7D67-479D-BA16-E4467A70B23F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0CEAE9-45EE-4036-8DC3-68BC050ACCAF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chart" Target="../charts/chart2.xml"/><Relationship Id="rId1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0955" y="41275"/>
            <a:ext cx="284607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Supplementary Figure </a:t>
            </a: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altLang="zh-C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5" name="图表 24"/>
          <p:cNvGraphicFramePr/>
          <p:nvPr/>
        </p:nvGraphicFramePr>
        <p:xfrm>
          <a:off x="0" y="857224"/>
          <a:ext cx="6984999" cy="30591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"/>
          </a:graphicData>
        </a:graphic>
      </p:graphicFrame>
      <p:graphicFrame>
        <p:nvGraphicFramePr>
          <p:cNvPr id="26" name="图表 25"/>
          <p:cNvGraphicFramePr/>
          <p:nvPr/>
        </p:nvGraphicFramePr>
        <p:xfrm>
          <a:off x="1481664" y="5072066"/>
          <a:ext cx="5376336" cy="32147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928670" y="571472"/>
            <a:ext cx="30718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GO_BP of miR-4709-3p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014396" y="4624386"/>
            <a:ext cx="30718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KEGG Pathway of miR-4709-3p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00016" y="495272"/>
            <a:ext cx="2857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09542" y="4476748"/>
            <a:ext cx="2857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548634" y="3714744"/>
            <a:ext cx="30718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nrichment.Score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-log10(P-value)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4</Words>
  <Application>WPS 演示</Application>
  <PresentationFormat>全屏显示(4:3)</PresentationFormat>
  <Paragraphs>12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Arial</vt:lpstr>
      <vt:lpstr>宋体</vt:lpstr>
      <vt:lpstr>Wingdings</vt:lpstr>
      <vt:lpstr>Calibri</vt:lpstr>
      <vt:lpstr>微软雅黑</vt:lpstr>
      <vt:lpstr>Arial Unicode MS</vt:lpstr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china</dc:creator>
  <cp:lastModifiedBy>hp</cp:lastModifiedBy>
  <cp:revision>96</cp:revision>
  <dcterms:created xsi:type="dcterms:W3CDTF">2014-09-03T01:40:00Z</dcterms:created>
  <dcterms:modified xsi:type="dcterms:W3CDTF">2018-07-04T14:12:5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7452</vt:lpwstr>
  </property>
</Properties>
</file>